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1" r:id="rId3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88888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128" y="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1"/>
            </a:lvl1pPr>
            <a:lvl2pPr marL="457181" indent="0" algn="ctr">
              <a:buNone/>
              <a:defRPr sz="2000"/>
            </a:lvl2pPr>
            <a:lvl3pPr marL="914362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3" indent="0" algn="ctr">
              <a:buNone/>
              <a:defRPr sz="1600"/>
            </a:lvl5pPr>
            <a:lvl6pPr marL="2285905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7776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371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4356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2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1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355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4813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1" b="1"/>
            </a:lvl1pPr>
            <a:lvl2pPr marL="457181" indent="0">
              <a:buNone/>
              <a:defRPr sz="2000" b="1"/>
            </a:lvl2pPr>
            <a:lvl3pPr marL="914362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3" indent="0">
              <a:buNone/>
              <a:defRPr sz="1600" b="1"/>
            </a:lvl5pPr>
            <a:lvl6pPr marL="2285905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845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979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14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199"/>
            </a:lvl1pPr>
            <a:lvl2pPr>
              <a:defRPr sz="2799"/>
            </a:lvl2pPr>
            <a:lvl3pPr>
              <a:defRPr sz="2401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7872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19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199"/>
            </a:lvl1pPr>
            <a:lvl2pPr marL="457181" indent="0">
              <a:buNone/>
              <a:defRPr sz="2799"/>
            </a:lvl2pPr>
            <a:lvl3pPr marL="914362" indent="0">
              <a:buNone/>
              <a:defRPr sz="2401"/>
            </a:lvl3pPr>
            <a:lvl4pPr marL="1371543" indent="0">
              <a:buNone/>
              <a:defRPr sz="2000"/>
            </a:lvl4pPr>
            <a:lvl5pPr marL="1828723" indent="0">
              <a:buNone/>
              <a:defRPr sz="2000"/>
            </a:lvl5pPr>
            <a:lvl6pPr marL="2285905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6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2" indent="0">
              <a:buNone/>
              <a:defRPr sz="1200"/>
            </a:lvl3pPr>
            <a:lvl4pPr marL="1371543" indent="0">
              <a:buNone/>
              <a:defRPr sz="1000"/>
            </a:lvl4pPr>
            <a:lvl5pPr marL="1828723" indent="0">
              <a:buNone/>
              <a:defRPr sz="1000"/>
            </a:lvl5pPr>
            <a:lvl6pPr marL="2285905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56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B868E-7131-4974-930B-EAFA130A02AA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93642-21CC-4BDF-B78F-82B0384EBBF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6016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71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1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2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5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2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3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6" algn="l" defTabSz="91436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mp"/><Relationship Id="rId2" Type="http://schemas.openxmlformats.org/officeDocument/2006/relationships/image" Target="../media/image3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04056" y="43502"/>
            <a:ext cx="41910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NanoString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differential expression output data for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 descr="Screen Clippi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7316" y="305112"/>
            <a:ext cx="4817013" cy="62337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/>
          <p:cNvSpPr txBox="1"/>
          <p:nvPr/>
        </p:nvSpPr>
        <p:spPr>
          <a:xfrm>
            <a:off x="4767716" y="6538893"/>
            <a:ext cx="22765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TAMs Score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 descr="Screen Clippi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761" y="305112"/>
            <a:ext cx="4445850" cy="62337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220132" y="6538893"/>
            <a:ext cx="26077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Total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score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780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01647" y="6537123"/>
            <a:ext cx="29887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TILs Altered vs Absent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84699" y="6534723"/>
            <a:ext cx="26406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 TILs High vs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sent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 descr="Screen Clippi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10" y="194732"/>
            <a:ext cx="4598241" cy="62722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 descr="Screen Clippi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485" y="194732"/>
            <a:ext cx="4868465" cy="627225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042058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6</TotalTime>
  <Words>30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ini Krishna</dc:creator>
  <cp:lastModifiedBy>yamini krishna</cp:lastModifiedBy>
  <cp:revision>127</cp:revision>
  <dcterms:created xsi:type="dcterms:W3CDTF">2019-12-08T09:57:48Z</dcterms:created>
  <dcterms:modified xsi:type="dcterms:W3CDTF">2020-09-17T06:21:25Z</dcterms:modified>
</cp:coreProperties>
</file>